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296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20" y="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34253-6AF6-2FF4-1599-154EBB2494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18C72B-A4DD-FE08-4E12-FE4DB7C131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CFCCEC-22D7-824E-7C60-F83C58893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D800C1-0932-2072-DF91-9D72CEDDD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D826D1-3EAE-1A76-14D6-2368BF757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25818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E632D-E5B3-D959-3F8E-35557213EC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EF5DD3-6477-F81C-1BAD-C7C55FB203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4E1432-2980-D899-3267-5CA479CAF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DBA9C7-57A8-58DF-9E7A-C37BDFF9F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2F060-5AE2-3362-C3B0-C24570C42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35538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DD936E-4350-9CD4-5BB3-9B0129374D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662B1D-B6B3-2F53-E30D-10CC367ACF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569010-3887-35A3-EF1E-C475AD08B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A10EC0-8A70-EFF7-F54A-BB43A2A81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D209EE-539E-2C2B-06EA-A81FF0D56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4793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70F1A7-6690-063C-F4D8-E2B9B29B28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CFB34D-3BED-AABE-6E50-2AF0CB9411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68D785-B240-3FCC-4904-CAC74AAC3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D8F436-8CE8-E31A-2339-19D7B4053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B0705F-2EE1-8676-56A5-6C77B252F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3018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A6902-3FF6-2937-439E-AB381D1559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9C0351-CB56-377A-8377-688FB99844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6A5B10-A8D0-7628-51CF-66BB56DF4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1E38CE-B53E-7B0C-3F2D-20F75A5D7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2EE070-D028-ED58-E083-7BD2CA8AA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34831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D14B4-C638-D049-F7B3-D61333B39E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1D3712-C2CD-963C-8DFB-3DB320BA9D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49C843-A4E9-92FB-2F21-A0465783A9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71E9C3-4BA9-A325-4CBA-A2DC56336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863432-E6E2-7934-E9E6-7DD6C085F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BE4969-E26B-5054-4500-23C998C59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18023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7B7540-D2F0-45F6-06D7-7F558D8FD1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6B2186-EF0A-0CAF-9D38-6E5F752724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120AAD-6342-DEC0-A9AD-D0CBE57903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A38226-FBCF-008B-D41B-CB1AE547B9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16C793-462A-5FA1-704F-A49FF287A5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3EB4C5-C385-21D8-56EA-7761128A9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5700F6-A5D6-A13C-4FCB-B17329553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AC7A83-6E30-1B92-28EB-D4450B39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75465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D9A84-1758-14BE-4E76-951758363C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C16505-C22C-D305-1473-02D3BC39C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3CACE9-830D-4C69-A892-3434635C1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2F6081-4AC2-BC8E-5702-7E9B77703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51143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23B9AD-D406-9D69-A77A-DFEDA81A6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F80BD7-5221-554A-E0EE-6E410C032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6A8E1F-8159-244D-76CE-BF4A097D6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30865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8CDA57-9E69-A26E-4ABB-829DD68B2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0EEDA5-0981-73AB-539A-DCEA54CBC7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C236C9-59D6-2C25-8EA3-F5BC84F754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CFA506-6CE3-2E5D-A668-B5EA1E6EE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C4A9DD-084D-9D6B-F9E8-E9A87E877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A28699-9405-A571-42B9-F07CF6899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85246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D089A-0DEB-D818-E854-655DD95F18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40D78A-F923-58B5-C103-F77CE06FB2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021813-8C22-AD4B-EC53-9EF9F9C5D6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FE69FB-F54A-9C87-2A14-B723D5497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E8198E-F9F2-F505-9D42-3900C85DB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142A49-9907-5345-993A-B069A79D4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460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04026B-352F-0E64-CC77-6C2136E6B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F25458-AF41-373B-166B-74B4CA231B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C3DA5-E543-2E1D-6F69-09209425EB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1DD552-0E56-4054-B6BC-0549920FE8CA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332AF-D86A-B30A-5228-17B6E037D1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0D481-A52A-C152-CED8-A165C8BC81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6667B3-1E23-4770-A4AC-63D5A281140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8210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B0A8A95-A823-8166-CE8A-2EBDF1065F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6005567"/>
              </p:ext>
            </p:extLst>
          </p:nvPr>
        </p:nvGraphicFramePr>
        <p:xfrm>
          <a:off x="715617" y="1161369"/>
          <a:ext cx="8428383" cy="363499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51483">
                  <a:extLst>
                    <a:ext uri="{9D8B030D-6E8A-4147-A177-3AD203B41FA5}">
                      <a16:colId xmlns:a16="http://schemas.microsoft.com/office/drawing/2014/main" val="2157845387"/>
                    </a:ext>
                  </a:extLst>
                </a:gridCol>
                <a:gridCol w="2762250">
                  <a:extLst>
                    <a:ext uri="{9D8B030D-6E8A-4147-A177-3AD203B41FA5}">
                      <a16:colId xmlns:a16="http://schemas.microsoft.com/office/drawing/2014/main" val="1698579339"/>
                    </a:ext>
                  </a:extLst>
                </a:gridCol>
                <a:gridCol w="2914650">
                  <a:extLst>
                    <a:ext uri="{9D8B030D-6E8A-4147-A177-3AD203B41FA5}">
                      <a16:colId xmlns:a16="http://schemas.microsoft.com/office/drawing/2014/main" val="2818783533"/>
                    </a:ext>
                  </a:extLst>
                </a:gridCol>
              </a:tblGrid>
              <a:tr h="164227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effectLst/>
                        </a:rPr>
                        <a:t>Variable</a:t>
                      </a:r>
                      <a:endParaRPr lang="nl-NL" sz="200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effectLst/>
                        </a:rPr>
                        <a:t>CNI (39)</a:t>
                      </a:r>
                      <a:endParaRPr lang="nl-NL" sz="200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effectLst/>
                        </a:rPr>
                        <a:t>Belatacept (31)</a:t>
                      </a:r>
                      <a:endParaRPr lang="nl-NL" sz="200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197894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Age (mean, SEM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 57 (2,1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55 (2,8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6263981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Female sex (n,%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 10 (26%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10 (32%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824073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LDL (mean, mmol/L, SEM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 2,7 (0,2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2,7 (0,2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746927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Months since transplantation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29 (3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33 (3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059967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Dialysis vintage in months 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14 (3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14 (3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355211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History of smoking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  <a:latin typeface="Cambria" panose="020405030504060302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4 (62%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14 (45%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517040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Diabetes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6 (15%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5 (16%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027882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Systolic BP (mmHg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135 (3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134 (2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053797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Diastolic BP (mmHg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82 (2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81 (2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039690"/>
                  </a:ext>
                </a:extLst>
              </a:tr>
              <a:tr h="8365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eGFR (ml/min/1.73m2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58 (3,2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52 (2,7)</a:t>
                      </a:r>
                      <a:endParaRPr lang="nl-NL" sz="20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114370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0C2361B-4AE3-BD61-9211-BEA4CC953DAB}"/>
              </a:ext>
            </a:extLst>
          </p:cNvPr>
          <p:cNvSpPr txBox="1"/>
          <p:nvPr/>
        </p:nvSpPr>
        <p:spPr>
          <a:xfrm>
            <a:off x="715617" y="5287617"/>
            <a:ext cx="595297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table 1:</a:t>
            </a:r>
          </a:p>
          <a:p>
            <a:r>
              <a:rPr lang="en-US" dirty="0"/>
              <a:t>Baseline characteristics of patients in micro-RNA-experiments</a:t>
            </a:r>
          </a:p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660595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52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mbri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edewold, O.W. (INT)</dc:creator>
  <cp:lastModifiedBy>Bredewold, Edwin (INT - LUMC)</cp:lastModifiedBy>
  <cp:revision>2</cp:revision>
  <dcterms:created xsi:type="dcterms:W3CDTF">2025-12-01T11:13:20Z</dcterms:created>
  <dcterms:modified xsi:type="dcterms:W3CDTF">2026-04-03T08:23:02Z</dcterms:modified>
</cp:coreProperties>
</file>